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12" r:id="rId2"/>
    <p:sldId id="310" r:id="rId3"/>
    <p:sldId id="296" r:id="rId4"/>
    <p:sldId id="297" r:id="rId5"/>
    <p:sldId id="311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9215BBB-19AD-0A63-E27D-41ABE3105A15}" name="Wijayalath Arachchige, Wathsala K CTR USN NMRC (USA)" initials="WW" userId="S::wathsala.k.wijayalatharachchige.ctr@health.mil::d743ecc4-38ae-4204-a3b4-fd5d652c624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2476"/>
    <a:srgbClr val="FFCCFF"/>
    <a:srgbClr val="091EB7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647" autoAdjust="0"/>
    <p:restoredTop sz="86311" autoAdjust="0"/>
  </p:normalViewPr>
  <p:slideViewPr>
    <p:cSldViewPr snapToGrid="0">
      <p:cViewPr>
        <p:scale>
          <a:sx n="84" d="100"/>
          <a:sy n="84" d="100"/>
        </p:scale>
        <p:origin x="1272" y="-23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ijayalath Arachchige, Wathsala K CTR USN NMRC (USA)" userId="d743ecc4-38ae-4204-a3b4-fd5d652c6243" providerId="ADAL" clId="{5E305D36-49F8-4BE6-89AD-AD219ADD1948}"/>
    <pc:docChg chg="modSld">
      <pc:chgData name="Wijayalath Arachchige, Wathsala K CTR USN NMRC (USA)" userId="d743ecc4-38ae-4204-a3b4-fd5d652c6243" providerId="ADAL" clId="{5E305D36-49F8-4BE6-89AD-AD219ADD1948}" dt="2025-10-15T21:33:34.018" v="33" actId="1037"/>
      <pc:docMkLst>
        <pc:docMk/>
      </pc:docMkLst>
      <pc:sldChg chg="modSp mod">
        <pc:chgData name="Wijayalath Arachchige, Wathsala K CTR USN NMRC (USA)" userId="d743ecc4-38ae-4204-a3b4-fd5d652c6243" providerId="ADAL" clId="{5E305D36-49F8-4BE6-89AD-AD219ADD1948}" dt="2025-10-15T16:13:45.163" v="11" actId="20577"/>
        <pc:sldMkLst>
          <pc:docMk/>
          <pc:sldMk cId="4018997983" sldId="296"/>
        </pc:sldMkLst>
        <pc:spChg chg="mod">
          <ac:chgData name="Wijayalath Arachchige, Wathsala K CTR USN NMRC (USA)" userId="d743ecc4-38ae-4204-a3b4-fd5d652c6243" providerId="ADAL" clId="{5E305D36-49F8-4BE6-89AD-AD219ADD1948}" dt="2025-10-15T16:13:45.163" v="11" actId="20577"/>
          <ac:spMkLst>
            <pc:docMk/>
            <pc:sldMk cId="4018997983" sldId="296"/>
            <ac:spMk id="4" creationId="{CE7A74FB-9E34-744B-7C99-AAD7D3565BD3}"/>
          </ac:spMkLst>
        </pc:spChg>
      </pc:sldChg>
      <pc:sldChg chg="modSp mod">
        <pc:chgData name="Wijayalath Arachchige, Wathsala K CTR USN NMRC (USA)" userId="d743ecc4-38ae-4204-a3b4-fd5d652c6243" providerId="ADAL" clId="{5E305D36-49F8-4BE6-89AD-AD219ADD1948}" dt="2025-10-15T21:33:34.018" v="33" actId="1037"/>
        <pc:sldMkLst>
          <pc:docMk/>
          <pc:sldMk cId="535306279" sldId="297"/>
        </pc:sldMkLst>
        <pc:spChg chg="mod">
          <ac:chgData name="Wijayalath Arachchige, Wathsala K CTR USN NMRC (USA)" userId="d743ecc4-38ae-4204-a3b4-fd5d652c6243" providerId="ADAL" clId="{5E305D36-49F8-4BE6-89AD-AD219ADD1948}" dt="2025-10-15T16:14:14.906" v="30" actId="20577"/>
          <ac:spMkLst>
            <pc:docMk/>
            <pc:sldMk cId="535306279" sldId="297"/>
            <ac:spMk id="5" creationId="{59331EBF-FB7C-1156-0CE1-3D91D64882F3}"/>
          </ac:spMkLst>
        </pc:spChg>
        <pc:spChg chg="mod">
          <ac:chgData name="Wijayalath Arachchige, Wathsala K CTR USN NMRC (USA)" userId="d743ecc4-38ae-4204-a3b4-fd5d652c6243" providerId="ADAL" clId="{5E305D36-49F8-4BE6-89AD-AD219ADD1948}" dt="2025-10-15T21:29:32.270" v="32" actId="1035"/>
          <ac:spMkLst>
            <pc:docMk/>
            <pc:sldMk cId="535306279" sldId="297"/>
            <ac:spMk id="6" creationId="{B5534E6E-1172-6D11-AFE0-BE4339A78CF3}"/>
          </ac:spMkLst>
        </pc:spChg>
        <pc:spChg chg="mod">
          <ac:chgData name="Wijayalath Arachchige, Wathsala K CTR USN NMRC (USA)" userId="d743ecc4-38ae-4204-a3b4-fd5d652c6243" providerId="ADAL" clId="{5E305D36-49F8-4BE6-89AD-AD219ADD1948}" dt="2025-10-15T21:33:34.018" v="33" actId="1037"/>
          <ac:spMkLst>
            <pc:docMk/>
            <pc:sldMk cId="535306279" sldId="297"/>
            <ac:spMk id="7" creationId="{93591626-ED69-2E0B-BD32-4B1986AAE3D2}"/>
          </ac:spMkLst>
        </pc:spChg>
      </pc:sldChg>
      <pc:sldChg chg="modSp mod">
        <pc:chgData name="Wijayalath Arachchige, Wathsala K CTR USN NMRC (USA)" userId="d743ecc4-38ae-4204-a3b4-fd5d652c6243" providerId="ADAL" clId="{5E305D36-49F8-4BE6-89AD-AD219ADD1948}" dt="2025-10-15T16:13:18.436" v="0" actId="6549"/>
        <pc:sldMkLst>
          <pc:docMk/>
          <pc:sldMk cId="23384102" sldId="312"/>
        </pc:sldMkLst>
        <pc:spChg chg="mod">
          <ac:chgData name="Wijayalath Arachchige, Wathsala K CTR USN NMRC (USA)" userId="d743ecc4-38ae-4204-a3b4-fd5d652c6243" providerId="ADAL" clId="{5E305D36-49F8-4BE6-89AD-AD219ADD1948}" dt="2025-10-15T16:13:18.436" v="0" actId="6549"/>
          <ac:spMkLst>
            <pc:docMk/>
            <pc:sldMk cId="23384102" sldId="312"/>
            <ac:spMk id="27" creationId="{2BCD92C4-6DBF-0628-9695-8EF86726F58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21E3F2-CFA4-45F8-A4BE-7E5C4737B697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91943D-070D-4E60-80E7-761951BBC3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020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91943D-070D-4E60-80E7-761951BBC3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5152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91943D-070D-4E60-80E7-761951BBC3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97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91943D-070D-4E60-80E7-761951BBC3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3352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91943D-070D-4E60-80E7-761951BBC3D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6195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91943D-070D-4E60-80E7-761951BBC3D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017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21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19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83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413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423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098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07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306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84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95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61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DD3A7-A94A-4E73-86A8-99826873AEA9}" type="datetimeFigureOut">
              <a:rPr lang="en-US" smtClean="0"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D92A4-09D3-4BC0-A326-E3BFBD08C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654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7.bin"/><Relationship Id="rId18" Type="http://schemas.openxmlformats.org/officeDocument/2006/relationships/image" Target="../media/image13.emf"/><Relationship Id="rId26" Type="http://schemas.openxmlformats.org/officeDocument/2006/relationships/image" Target="../media/image17.emf"/><Relationship Id="rId39" Type="http://schemas.openxmlformats.org/officeDocument/2006/relationships/oleObject" Target="../embeddings/oleObject20.bin"/><Relationship Id="rId21" Type="http://schemas.openxmlformats.org/officeDocument/2006/relationships/oleObject" Target="../embeddings/oleObject11.bin"/><Relationship Id="rId34" Type="http://schemas.openxmlformats.org/officeDocument/2006/relationships/image" Target="../media/image21.emf"/><Relationship Id="rId7" Type="http://schemas.openxmlformats.org/officeDocument/2006/relationships/oleObject" Target="../embeddings/oleObject4.bin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9.bin"/><Relationship Id="rId25" Type="http://schemas.openxmlformats.org/officeDocument/2006/relationships/oleObject" Target="../embeddings/oleObject13.bin"/><Relationship Id="rId33" Type="http://schemas.openxmlformats.org/officeDocument/2006/relationships/oleObject" Target="../embeddings/oleObject17.bin"/><Relationship Id="rId38" Type="http://schemas.openxmlformats.org/officeDocument/2006/relationships/image" Target="../media/image23.em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12.emf"/><Relationship Id="rId20" Type="http://schemas.openxmlformats.org/officeDocument/2006/relationships/image" Target="../media/image14.emf"/><Relationship Id="rId29" Type="http://schemas.openxmlformats.org/officeDocument/2006/relationships/oleObject" Target="../embeddings/oleObject15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6.bin"/><Relationship Id="rId24" Type="http://schemas.openxmlformats.org/officeDocument/2006/relationships/image" Target="../media/image16.emf"/><Relationship Id="rId32" Type="http://schemas.openxmlformats.org/officeDocument/2006/relationships/image" Target="../media/image20.emf"/><Relationship Id="rId37" Type="http://schemas.openxmlformats.org/officeDocument/2006/relationships/oleObject" Target="../embeddings/oleObject19.bin"/><Relationship Id="rId40" Type="http://schemas.openxmlformats.org/officeDocument/2006/relationships/image" Target="../media/image24.emf"/><Relationship Id="rId5" Type="http://schemas.openxmlformats.org/officeDocument/2006/relationships/oleObject" Target="../embeddings/oleObject3.bin"/><Relationship Id="rId15" Type="http://schemas.openxmlformats.org/officeDocument/2006/relationships/oleObject" Target="../embeddings/oleObject8.bin"/><Relationship Id="rId23" Type="http://schemas.openxmlformats.org/officeDocument/2006/relationships/oleObject" Target="../embeddings/oleObject12.bin"/><Relationship Id="rId28" Type="http://schemas.openxmlformats.org/officeDocument/2006/relationships/image" Target="../media/image18.emf"/><Relationship Id="rId36" Type="http://schemas.openxmlformats.org/officeDocument/2006/relationships/image" Target="../media/image22.emf"/><Relationship Id="rId10" Type="http://schemas.openxmlformats.org/officeDocument/2006/relationships/image" Target="../media/image9.emf"/><Relationship Id="rId19" Type="http://schemas.openxmlformats.org/officeDocument/2006/relationships/oleObject" Target="../embeddings/oleObject10.bin"/><Relationship Id="rId31" Type="http://schemas.openxmlformats.org/officeDocument/2006/relationships/oleObject" Target="../embeddings/oleObject16.bin"/><Relationship Id="rId4" Type="http://schemas.openxmlformats.org/officeDocument/2006/relationships/image" Target="../media/image6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1.emf"/><Relationship Id="rId22" Type="http://schemas.openxmlformats.org/officeDocument/2006/relationships/image" Target="../media/image15.emf"/><Relationship Id="rId27" Type="http://schemas.openxmlformats.org/officeDocument/2006/relationships/oleObject" Target="../embeddings/oleObject14.bin"/><Relationship Id="rId30" Type="http://schemas.openxmlformats.org/officeDocument/2006/relationships/image" Target="../media/image19.emf"/><Relationship Id="rId35" Type="http://schemas.openxmlformats.org/officeDocument/2006/relationships/oleObject" Target="../embeddings/oleObject18.bin"/><Relationship Id="rId8" Type="http://schemas.openxmlformats.org/officeDocument/2006/relationships/image" Target="../media/image8.emf"/><Relationship Id="rId3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2746BC5-B4E3-3F9E-0F35-C33C1E34089D}"/>
              </a:ext>
            </a:extLst>
          </p:cNvPr>
          <p:cNvGrpSpPr/>
          <p:nvPr/>
        </p:nvGrpSpPr>
        <p:grpSpPr>
          <a:xfrm>
            <a:off x="-493924" y="36972"/>
            <a:ext cx="8318399" cy="10036988"/>
            <a:chOff x="-423091" y="69169"/>
            <a:chExt cx="8318399" cy="1003698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94C5939-68A9-9217-27B8-922DC22EED70}"/>
                </a:ext>
              </a:extLst>
            </p:cNvPr>
            <p:cNvSpPr txBox="1"/>
            <p:nvPr/>
          </p:nvSpPr>
          <p:spPr>
            <a:xfrm>
              <a:off x="702945" y="69169"/>
              <a:ext cx="69189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latonin and Vaccine Response, Immunity, and Chronobiology Study (MAVRICS)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29CA618D-A7AE-968A-29FA-EA2E8EF4E9A8}"/>
                </a:ext>
              </a:extLst>
            </p:cNvPr>
            <p:cNvGrpSpPr/>
            <p:nvPr/>
          </p:nvGrpSpPr>
          <p:grpSpPr>
            <a:xfrm>
              <a:off x="510726" y="442415"/>
              <a:ext cx="7384582" cy="855055"/>
              <a:chOff x="510726" y="424566"/>
              <a:chExt cx="7384582" cy="943933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9F2D821-C2A2-68E3-ECEF-596F8DF9CCF4}"/>
                  </a:ext>
                </a:extLst>
              </p:cNvPr>
              <p:cNvSpPr txBox="1"/>
              <p:nvPr/>
            </p:nvSpPr>
            <p:spPr>
              <a:xfrm>
                <a:off x="805702" y="424566"/>
                <a:ext cx="7089606" cy="5436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Q</a:t>
                </a:r>
                <a:r>
                  <a:rPr lang="en-US" sz="1400" b="1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uadrivalent inactivated influenza vaccine (IIV4) (2022/23 season) </a:t>
                </a:r>
              </a:p>
              <a:p>
                <a:pPr algn="ctr"/>
                <a:r>
                  <a:rPr lang="en-US" sz="12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administered between 8am-4pm)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C527C8C-6AB5-3C0C-0E43-E6A48C7E6B64}"/>
                  </a:ext>
                </a:extLst>
              </p:cNvPr>
              <p:cNvSpPr txBox="1"/>
              <p:nvPr/>
            </p:nvSpPr>
            <p:spPr>
              <a:xfrm>
                <a:off x="510726" y="858846"/>
                <a:ext cx="6918960" cy="50965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/Victoria/2570/2019 (H1N1) pdm09-like virus, A/Darwin/9/2021 (H3N2), B/Austria/1359417/2021 (B/Victoria lineage), and B/Phuket/3073/2013 (B/Yamagata lineage) 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00028A-F6E4-33F0-C5A0-9C324C2A7FB7}"/>
                </a:ext>
              </a:extLst>
            </p:cNvPr>
            <p:cNvSpPr txBox="1"/>
            <p:nvPr/>
          </p:nvSpPr>
          <p:spPr>
            <a:xfrm>
              <a:off x="3298197" y="1395839"/>
              <a:ext cx="1547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sion criteri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F921A92-9917-E5CF-166A-44FCA7011BED}"/>
                </a:ext>
              </a:extLst>
            </p:cNvPr>
            <p:cNvSpPr txBox="1"/>
            <p:nvPr/>
          </p:nvSpPr>
          <p:spPr>
            <a:xfrm>
              <a:off x="245297" y="1612072"/>
              <a:ext cx="4042407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luenza vaccination within past 6 months prior to enrollment </a:t>
              </a:r>
            </a:p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allergy or contraindication to influenza vaccine(s)</a:t>
              </a:r>
            </a:p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ical history of an immune-compromising medical condition (i.e., HIV, active cancer, etc.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A79FAF5-9B65-D3FE-42A9-B30C8D6D2B74}"/>
                </a:ext>
              </a:extLst>
            </p:cNvPr>
            <p:cNvSpPr txBox="1"/>
            <p:nvPr/>
          </p:nvSpPr>
          <p:spPr>
            <a:xfrm>
              <a:off x="2257425" y="2772883"/>
              <a:ext cx="381000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althy adults aged 18-64 years (randomized) 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C68E8F4-1F25-166A-BDD2-EDA2BDD2786B}"/>
                </a:ext>
              </a:extLst>
            </p:cNvPr>
            <p:cNvSpPr txBox="1"/>
            <p:nvPr/>
          </p:nvSpPr>
          <p:spPr>
            <a:xfrm>
              <a:off x="837876" y="3184873"/>
              <a:ext cx="22783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latonin (treatment), n=53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28260A2-6800-F915-EDC7-AAB1529D2EB8}"/>
                </a:ext>
              </a:extLst>
            </p:cNvPr>
            <p:cNvSpPr txBox="1"/>
            <p:nvPr/>
          </p:nvSpPr>
          <p:spPr>
            <a:xfrm>
              <a:off x="4729423" y="3196420"/>
              <a:ext cx="22783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 melatonin (control), n=55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E5DF00E-42CB-EE50-C310-7BA223DD64D0}"/>
                </a:ext>
              </a:extLst>
            </p:cNvPr>
            <p:cNvSpPr txBox="1"/>
            <p:nvPr/>
          </p:nvSpPr>
          <p:spPr>
            <a:xfrm>
              <a:off x="371152" y="3444222"/>
              <a:ext cx="3195638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Mfresh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® 5mg caplets,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e hour before their planned bedtime for 14 days, starting on the night of influenza vaccination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CF21BE1-9629-8838-E0DC-28BAC4EB40E4}"/>
                </a:ext>
              </a:extLst>
            </p:cNvPr>
            <p:cNvSpPr txBox="1"/>
            <p:nvPr/>
          </p:nvSpPr>
          <p:spPr>
            <a:xfrm>
              <a:off x="456469" y="4182430"/>
              <a:ext cx="6995799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erum and Peripheral Blood Mononuclear Cells (PBMCs) 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collected between 8am-4pm)</a:t>
              </a:r>
            </a:p>
            <a:p>
              <a:pPr algn="ctr"/>
              <a:r>
                <a:rPr lang="en-US" sz="14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24-48 hours (week 0) before and 14-21 days (2-3 weeks) after the influenza vaccination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7B491A6-591D-B14B-EA35-DFEB1479EC4D}"/>
                </a:ext>
              </a:extLst>
            </p:cNvPr>
            <p:cNvSpPr txBox="1"/>
            <p:nvPr/>
          </p:nvSpPr>
          <p:spPr>
            <a:xfrm>
              <a:off x="626746" y="5138989"/>
              <a:ext cx="22783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A63684E-3AC5-CAED-9D41-5D780E9C29EB}"/>
                </a:ext>
              </a:extLst>
            </p:cNvPr>
            <p:cNvSpPr txBox="1"/>
            <p:nvPr/>
          </p:nvSpPr>
          <p:spPr>
            <a:xfrm>
              <a:off x="269868" y="4926914"/>
              <a:ext cx="3066870" cy="4924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verall analysis 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o stratification by HAI baseline titers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9283A5C-6005-0C57-7C4C-759F49DC19E7}"/>
                </a:ext>
              </a:extLst>
            </p:cNvPr>
            <p:cNvSpPr txBox="1"/>
            <p:nvPr/>
          </p:nvSpPr>
          <p:spPr>
            <a:xfrm>
              <a:off x="3396436" y="4937527"/>
              <a:ext cx="4465417" cy="123110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ratified analysis 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stratified by A/Victoria/2570/2019 HAI baseline titers) </a:t>
              </a:r>
            </a:p>
            <a:p>
              <a:pPr algn="ctr"/>
              <a:r>
                <a:rPr 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baseline - HAI titer above 1:100</a:t>
              </a:r>
            </a:p>
            <a:p>
              <a:pPr algn="ctr"/>
              <a:r>
                <a:rPr 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w baseline - HAI titer below 1:100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 high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Control high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3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 low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Control low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1 (except for serum cytokines)</a:t>
              </a:r>
              <a:endParaRPr 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56487B5-010C-7E45-4BE4-EFFEF5678070}"/>
                </a:ext>
              </a:extLst>
            </p:cNvPr>
            <p:cNvSpPr txBox="1"/>
            <p:nvPr/>
          </p:nvSpPr>
          <p:spPr>
            <a:xfrm>
              <a:off x="-423091" y="5760267"/>
              <a:ext cx="3819527" cy="193899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742950" marR="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Hemagglutination-inhibition (HAI) assay</a:t>
              </a:r>
            </a:p>
            <a:p>
              <a:pPr marR="0" lvl="1"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Melatonin treatment (n=53), Control (n=55)</a:t>
              </a:r>
            </a:p>
            <a:p>
              <a:pPr marR="0" lvl="1">
                <a:tabLst>
                  <a:tab pos="360045" algn="l"/>
                </a:tabLst>
              </a:pPr>
              <a:endPara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endParaRPr>
            </a:p>
            <a:p>
              <a:pPr marL="742950" marR="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ntigen-specific, activated T cell responses including circulating T Follicular Helper (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cTfh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) subsets by flow-cytometry</a:t>
              </a:r>
            </a:p>
            <a:p>
              <a:pPr marR="0" lvl="1"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Melatonin treatment (n=34), Control (n=36)</a:t>
              </a:r>
              <a:endParaRPr lang="en-US" sz="12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BCD92C4-6DBF-0628-9695-8EF86726F580}"/>
                </a:ext>
              </a:extLst>
            </p:cNvPr>
            <p:cNvSpPr txBox="1"/>
            <p:nvPr/>
          </p:nvSpPr>
          <p:spPr>
            <a:xfrm>
              <a:off x="3254729" y="6351283"/>
              <a:ext cx="4640579" cy="37548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742950" marR="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/Victoria/2570/2019 HAI titers</a:t>
              </a:r>
            </a:p>
            <a:p>
              <a:pPr marR="0" lvl="1"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</a:t>
              </a:r>
              <a:endPara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endParaRPr>
            </a:p>
            <a:p>
              <a:pPr marL="74295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ntigen-specific, activated T cell responses, including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cTfh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mbria" panose="02040503050406030204" pitchFamily="18" charset="0"/>
                  <a:cs typeface="Times New Roman" panose="02020603050405020304" pitchFamily="18" charset="0"/>
                </a:rPr>
                <a:t>) by flow-cytometry (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mulating PBMCs with recombinant Hemagglutinin (HA) proteins) </a:t>
              </a:r>
            </a:p>
            <a:p>
              <a:pPr marR="0" lvl="1">
                <a:tabLst>
                  <a:tab pos="360045" algn="l"/>
                </a:tabLst>
              </a:pPr>
              <a:endParaRPr lang="en-US" sz="12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endParaRPr>
            </a:p>
            <a:p>
              <a:pPr marL="74295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kine/chemokine analysis by mesoscale assays</a:t>
              </a:r>
            </a:p>
            <a:p>
              <a:pPr marL="1085850" lvl="2" indent="-171450">
                <a:buFont typeface="Wingdings" panose="05000000000000000000" pitchFamily="2" charset="2"/>
                <a:buChar char="Ø"/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obal cytokine profile (Serum)</a:t>
              </a:r>
              <a:r>
                <a:rPr lang="en-US" dirty="0"/>
                <a:t> </a:t>
              </a:r>
            </a:p>
            <a:p>
              <a:pPr lvl="2"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Melatonin high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9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Control high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9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	Melatonin low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4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Control low,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4</a:t>
              </a:r>
            </a:p>
            <a:p>
              <a:pPr marL="1085850" lvl="2" indent="-171450">
                <a:buFont typeface="Wingdings" panose="05000000000000000000" pitchFamily="2" charset="2"/>
                <a:buChar char="Ø"/>
                <a:tabLst>
                  <a:tab pos="360045" algn="l"/>
                </a:tabLst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gen-specific – (Culture supernatant after stimulating PBMCs with Recombinant HA proteins) </a:t>
              </a:r>
            </a:p>
            <a:p>
              <a:pPr lvl="1">
                <a:tabLst>
                  <a:tab pos="360045" algn="l"/>
                </a:tabLst>
              </a:pP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742950" lvl="1" indent="-285750">
                <a:buFont typeface="Wingdings" panose="05000000000000000000" pitchFamily="2" charset="2"/>
                <a:buChar char="ü"/>
                <a:tabLst>
                  <a:tab pos="360045" algn="l"/>
                </a:tabLst>
              </a:pP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signaling factors by MILLIPLEX ® bead-based Luminex assay –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ell fraction without the activated CD154+ cells)</a:t>
              </a:r>
            </a:p>
            <a:p>
              <a:pPr lvl="1">
                <a:tabLst>
                  <a:tab pos="360045" algn="l"/>
                </a:tabLst>
              </a:pP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R="0" lvl="1">
                <a:tabLst>
                  <a:tab pos="360045" algn="l"/>
                </a:tabLst>
              </a:pPr>
              <a:endParaRPr lang="en-US" sz="12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A96009A-49CA-252C-4E69-499AEAF5DB4E}"/>
                </a:ext>
              </a:extLst>
            </p:cNvPr>
            <p:cNvSpPr txBox="1"/>
            <p:nvPr/>
          </p:nvSpPr>
          <p:spPr>
            <a:xfrm>
              <a:off x="3814764" y="1609636"/>
              <a:ext cx="3957636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diagnosed sleep disorder requiring medication </a:t>
              </a:r>
            </a:p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gnancy</a:t>
              </a:r>
            </a:p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ent history of taking immunosuppressant or immune-modifying treatment within past three months</a:t>
              </a:r>
            </a:p>
            <a:p>
              <a:pPr marL="171450" indent="-171450">
                <a:buFont typeface="Wingdings" panose="05000000000000000000" pitchFamily="2" charset="2"/>
                <a:buChar char="q"/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e of sleep supplements or medications in the past month </a:t>
              </a:r>
            </a:p>
          </p:txBody>
        </p:sp>
        <p:sp>
          <p:nvSpPr>
            <p:cNvPr id="30" name="Arrow: Down 29">
              <a:extLst>
                <a:ext uri="{FF2B5EF4-FFF2-40B4-BE49-F238E27FC236}">
                  <a16:creationId xmlns:a16="http://schemas.microsoft.com/office/drawing/2014/main" id="{63E575E2-4CC2-8752-52A0-647F454022FC}"/>
                </a:ext>
              </a:extLst>
            </p:cNvPr>
            <p:cNvSpPr/>
            <p:nvPr/>
          </p:nvSpPr>
          <p:spPr>
            <a:xfrm>
              <a:off x="3868606" y="339455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Arrow: Down 30">
              <a:extLst>
                <a:ext uri="{FF2B5EF4-FFF2-40B4-BE49-F238E27FC236}">
                  <a16:creationId xmlns:a16="http://schemas.microsoft.com/office/drawing/2014/main" id="{D725F415-1B91-8E67-5F0F-ACE688CE9A26}"/>
                </a:ext>
              </a:extLst>
            </p:cNvPr>
            <p:cNvSpPr/>
            <p:nvPr/>
          </p:nvSpPr>
          <p:spPr>
            <a:xfrm>
              <a:off x="3870326" y="1306686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Arrow: Down 31">
              <a:extLst>
                <a:ext uri="{FF2B5EF4-FFF2-40B4-BE49-F238E27FC236}">
                  <a16:creationId xmlns:a16="http://schemas.microsoft.com/office/drawing/2014/main" id="{3A75B017-C3FB-21B7-F961-34ACAA46A19F}"/>
                </a:ext>
              </a:extLst>
            </p:cNvPr>
            <p:cNvSpPr/>
            <p:nvPr/>
          </p:nvSpPr>
          <p:spPr>
            <a:xfrm>
              <a:off x="3870326" y="2636269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Arrow: Down 32">
              <a:extLst>
                <a:ext uri="{FF2B5EF4-FFF2-40B4-BE49-F238E27FC236}">
                  <a16:creationId xmlns:a16="http://schemas.microsoft.com/office/drawing/2014/main" id="{79F7FEFC-8F63-906A-43C7-AFC20CBD7ED5}"/>
                </a:ext>
              </a:extLst>
            </p:cNvPr>
            <p:cNvSpPr/>
            <p:nvPr/>
          </p:nvSpPr>
          <p:spPr>
            <a:xfrm>
              <a:off x="3870326" y="4012528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8CA31319-0677-FB58-A1C4-A32E8FA7D7A9}"/>
                </a:ext>
              </a:extLst>
            </p:cNvPr>
            <p:cNvGrpSpPr/>
            <p:nvPr/>
          </p:nvGrpSpPr>
          <p:grpSpPr>
            <a:xfrm>
              <a:off x="3336738" y="3021977"/>
              <a:ext cx="1235262" cy="406901"/>
              <a:chOff x="3375026" y="3093609"/>
              <a:chExt cx="1188720" cy="490296"/>
            </a:xfrm>
          </p:grpSpPr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E9D0E3AA-075F-DCD1-A480-E20307D4BC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4626" y="3093609"/>
                <a:ext cx="0" cy="261696"/>
              </a:xfrm>
              <a:prstGeom prst="line">
                <a:avLst/>
              </a:prstGeom>
              <a:ln w="5715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78552A6D-202A-D285-EDA5-21DE29C9A5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375026" y="3329905"/>
                <a:ext cx="1188720" cy="1488"/>
              </a:xfrm>
              <a:prstGeom prst="line">
                <a:avLst/>
              </a:prstGeom>
              <a:ln w="5715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A9D3EED2-AE3B-A449-AC35-7B3BDED0BB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00426" y="3309509"/>
                <a:ext cx="0" cy="261696"/>
              </a:xfrm>
              <a:prstGeom prst="line">
                <a:avLst/>
              </a:prstGeom>
              <a:ln w="5715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330EEE6B-225C-25D8-78B5-5B4C1EBBAD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38582" y="3322209"/>
                <a:ext cx="0" cy="261696"/>
              </a:xfrm>
              <a:prstGeom prst="line">
                <a:avLst/>
              </a:prstGeom>
              <a:ln w="5715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43" name="Arrow: Down 42">
              <a:extLst>
                <a:ext uri="{FF2B5EF4-FFF2-40B4-BE49-F238E27FC236}">
                  <a16:creationId xmlns:a16="http://schemas.microsoft.com/office/drawing/2014/main" id="{FD6C167D-596C-1B87-CFF0-9860E341BCC5}"/>
                </a:ext>
              </a:extLst>
            </p:cNvPr>
            <p:cNvSpPr/>
            <p:nvPr/>
          </p:nvSpPr>
          <p:spPr>
            <a:xfrm>
              <a:off x="1666786" y="4769780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Arrow: Down 43">
              <a:extLst>
                <a:ext uri="{FF2B5EF4-FFF2-40B4-BE49-F238E27FC236}">
                  <a16:creationId xmlns:a16="http://schemas.microsoft.com/office/drawing/2014/main" id="{B1B12E73-733F-0DDA-2514-55E4A319EBDD}"/>
                </a:ext>
              </a:extLst>
            </p:cNvPr>
            <p:cNvSpPr/>
            <p:nvPr/>
          </p:nvSpPr>
          <p:spPr>
            <a:xfrm>
              <a:off x="1666786" y="5533550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Arrow: Down 44">
              <a:extLst>
                <a:ext uri="{FF2B5EF4-FFF2-40B4-BE49-F238E27FC236}">
                  <a16:creationId xmlns:a16="http://schemas.microsoft.com/office/drawing/2014/main" id="{88441AAB-4E4E-838F-49C0-C23E37041523}"/>
                </a:ext>
              </a:extLst>
            </p:cNvPr>
            <p:cNvSpPr/>
            <p:nvPr/>
          </p:nvSpPr>
          <p:spPr>
            <a:xfrm>
              <a:off x="5527544" y="4744633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Arrow: Down 45">
              <a:extLst>
                <a:ext uri="{FF2B5EF4-FFF2-40B4-BE49-F238E27FC236}">
                  <a16:creationId xmlns:a16="http://schemas.microsoft.com/office/drawing/2014/main" id="{8728EB44-3D5C-026E-4B11-D78A4EC830EC}"/>
                </a:ext>
              </a:extLst>
            </p:cNvPr>
            <p:cNvSpPr/>
            <p:nvPr/>
          </p:nvSpPr>
          <p:spPr>
            <a:xfrm>
              <a:off x="5527544" y="6177178"/>
              <a:ext cx="203200" cy="174105"/>
            </a:xfrm>
            <a:prstGeom prst="downArrow">
              <a:avLst/>
            </a:prstGeom>
            <a:solidFill>
              <a:schemeClr val="accent2"/>
            </a:solidFill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6F802A3-0B9D-9956-A62B-7EE728A6EC86}"/>
                </a:ext>
              </a:extLst>
            </p:cNvPr>
            <p:cNvSpPr txBox="1"/>
            <p:nvPr/>
          </p:nvSpPr>
          <p:spPr>
            <a:xfrm>
              <a:off x="269868" y="8152033"/>
              <a:ext cx="3161992" cy="12618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1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</a:t>
              </a:r>
              <a:r>
                <a:rPr lang="en-US" sz="14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chematic representation of the research study design based on the </a:t>
              </a:r>
              <a:r>
                <a:rPr lang="en-US" sz="14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VRICS clinical study samples </a:t>
              </a:r>
              <a:r>
                <a:rPr lang="en-US" sz="10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0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riginal clinical study can be fount at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oi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10.1080/21645515.2024.2419742, citation number 45 under the references in the research article)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384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6CA7644-1583-CEDA-4486-72DFC1BA49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5925982"/>
              </p:ext>
            </p:extLst>
          </p:nvPr>
        </p:nvGraphicFramePr>
        <p:xfrm>
          <a:off x="590550" y="341500"/>
          <a:ext cx="6591300" cy="383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7900997" imgH="4597430" progId="Prism10.Document">
                  <p:embed/>
                </p:oleObj>
              </mc:Choice>
              <mc:Fallback>
                <p:oleObj name="Prism 10" r:id="rId3" imgW="7900997" imgH="4597430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6CA7644-1583-CEDA-4486-72DFC1BA49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0550" y="341500"/>
                        <a:ext cx="6591300" cy="3835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1CDE4F2-C2D5-8084-06ED-02E96B8A5FDE}"/>
              </a:ext>
            </a:extLst>
          </p:cNvPr>
          <p:cNvSpPr txBox="1"/>
          <p:nvPr/>
        </p:nvSpPr>
        <p:spPr>
          <a:xfrm>
            <a:off x="590550" y="4552146"/>
            <a:ext cx="691290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  <a:tabLst>
                <a:tab pos="3701415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e distribution of the MAVRICS study participants across the high and low A/Victoria HAI baseline groups in the melatonin recipients and control vaccinees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latonin high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Control high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3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Melatonin low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Control low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1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468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5B3F8E3E-E17E-DCD2-30F8-426E90CA2CDA}"/>
              </a:ext>
            </a:extLst>
          </p:cNvPr>
          <p:cNvGrpSpPr/>
          <p:nvPr/>
        </p:nvGrpSpPr>
        <p:grpSpPr>
          <a:xfrm>
            <a:off x="93929" y="198234"/>
            <a:ext cx="5435245" cy="4572000"/>
            <a:chOff x="435428" y="169277"/>
            <a:chExt cx="5435245" cy="45720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DC0E3C3-1AB7-775E-AE5B-824A429F2E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5428" y="169277"/>
              <a:ext cx="5435245" cy="457200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1309457A-6C4B-E4FB-848F-8F9A433DB1E2}"/>
                </a:ext>
              </a:extLst>
            </p:cNvPr>
            <p:cNvSpPr/>
            <p:nvPr/>
          </p:nvSpPr>
          <p:spPr>
            <a:xfrm>
              <a:off x="1494361" y="2403245"/>
              <a:ext cx="1764792" cy="1746504"/>
            </a:xfrm>
            <a:prstGeom prst="rect">
              <a:avLst/>
            </a:prstGeom>
            <a:solidFill>
              <a:schemeClr val="accent2">
                <a:lumMod val="20000"/>
                <a:lumOff val="80000"/>
                <a:alpha val="37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9EAEAA0-3B05-77F2-8CE0-D50C76949D76}"/>
              </a:ext>
            </a:extLst>
          </p:cNvPr>
          <p:cNvGrpSpPr/>
          <p:nvPr/>
        </p:nvGrpSpPr>
        <p:grpSpPr>
          <a:xfrm>
            <a:off x="105648" y="5381869"/>
            <a:ext cx="5435245" cy="4572000"/>
            <a:chOff x="435428" y="4827235"/>
            <a:chExt cx="5435245" cy="45720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7393525-87EE-0482-33BC-B203C15AB9F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5428" y="4827235"/>
              <a:ext cx="5435245" cy="457200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302A196-D1D0-0D43-CB1D-A09374F2511D}"/>
                </a:ext>
              </a:extLst>
            </p:cNvPr>
            <p:cNvSpPr/>
            <p:nvPr/>
          </p:nvSpPr>
          <p:spPr>
            <a:xfrm>
              <a:off x="1477108" y="7035490"/>
              <a:ext cx="1773936" cy="1773936"/>
            </a:xfrm>
            <a:prstGeom prst="rect">
              <a:avLst/>
            </a:prstGeom>
            <a:solidFill>
              <a:srgbClr val="92D050">
                <a:alpha val="11000"/>
              </a:srgb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E37E8C9-C204-E9D9-FB0C-2AB0C650B22E}"/>
              </a:ext>
            </a:extLst>
          </p:cNvPr>
          <p:cNvSpPr txBox="1"/>
          <p:nvPr/>
        </p:nvSpPr>
        <p:spPr>
          <a:xfrm>
            <a:off x="426294" y="-498"/>
            <a:ext cx="44296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A) Melatonin treated, High HAI Baselin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2BC7DEC-4CEA-7909-EC7C-E4FEC3706F16}"/>
              </a:ext>
            </a:extLst>
          </p:cNvPr>
          <p:cNvSpPr txBox="1"/>
          <p:nvPr/>
        </p:nvSpPr>
        <p:spPr>
          <a:xfrm>
            <a:off x="504639" y="5043315"/>
            <a:ext cx="34364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 Control, High HAI Baseline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E7A74FB-9E34-744B-7C99-AAD7D3565BD3}"/>
              </a:ext>
            </a:extLst>
          </p:cNvPr>
          <p:cNvSpPr txBox="1"/>
          <p:nvPr/>
        </p:nvSpPr>
        <p:spPr>
          <a:xfrm>
            <a:off x="5013574" y="490770"/>
            <a:ext cx="2758826" cy="4616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1200"/>
              </a:spcBef>
              <a:spcAft>
                <a:spcPts val="1200"/>
              </a:spcAft>
              <a:tabLst>
                <a:tab pos="3701415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Effect of pre-existing titers on post-vaccination fold-change of the HAI titers and HA antigen-specific immune mediators in the high HAI baseline group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matrices show the correlation between pre-existing titers (pre) and post-vaccination fold-change (FC) of the selected immune mediators in the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latonin recipients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vaccinees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3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Only significant correlations (P &lt; 0.05) are displayed in each correlation matrix. Positive correlations, blue; Negative correlations, red. Color intensity and the size of the circle are proportional to the correlation coefficients (r) calculated using Spearman R. </a:t>
            </a:r>
          </a:p>
        </p:txBody>
      </p:sp>
    </p:spTree>
    <p:extLst>
      <p:ext uri="{BB962C8B-B14F-4D97-AF65-F5344CB8AC3E}">
        <p14:creationId xmlns:p14="http://schemas.microsoft.com/office/powerpoint/2010/main" val="4018997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3BBC34F-5CF9-EC12-2DF7-020A16E0FC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797"/>
            <a:ext cx="5435245" cy="4572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5534E6E-1172-6D11-AFE0-BE4339A78CF3}"/>
              </a:ext>
            </a:extLst>
          </p:cNvPr>
          <p:cNvSpPr/>
          <p:nvPr/>
        </p:nvSpPr>
        <p:spPr>
          <a:xfrm>
            <a:off x="1244699" y="2363393"/>
            <a:ext cx="1641231" cy="1617784"/>
          </a:xfrm>
          <a:prstGeom prst="rect">
            <a:avLst/>
          </a:prstGeom>
          <a:solidFill>
            <a:srgbClr val="FFCCFF">
              <a:alpha val="35000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A5C95CD-158C-2BF0-5E4E-433A2E68CEBE}"/>
              </a:ext>
            </a:extLst>
          </p:cNvPr>
          <p:cNvGrpSpPr/>
          <p:nvPr/>
        </p:nvGrpSpPr>
        <p:grpSpPr>
          <a:xfrm>
            <a:off x="116926" y="5276535"/>
            <a:ext cx="5435245" cy="4572000"/>
            <a:chOff x="289311" y="5029200"/>
            <a:chExt cx="5435245" cy="4572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6666EF5-88A2-1F5D-EAF0-82D784F604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9311" y="5029200"/>
              <a:ext cx="5435245" cy="457200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3591626-ED69-2E0B-BD32-4B1986AAE3D2}"/>
                </a:ext>
              </a:extLst>
            </p:cNvPr>
            <p:cNvSpPr/>
            <p:nvPr/>
          </p:nvSpPr>
          <p:spPr>
            <a:xfrm>
              <a:off x="1348446" y="7242797"/>
              <a:ext cx="1755648" cy="1783080"/>
            </a:xfrm>
            <a:prstGeom prst="rect">
              <a:avLst/>
            </a:prstGeom>
            <a:solidFill>
              <a:schemeClr val="accent1">
                <a:lumMod val="60000"/>
                <a:lumOff val="40000"/>
                <a:alpha val="21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2AB6530-1421-B5B1-04E4-C5D3646AE34A}"/>
              </a:ext>
            </a:extLst>
          </p:cNvPr>
          <p:cNvSpPr txBox="1"/>
          <p:nvPr/>
        </p:nvSpPr>
        <p:spPr>
          <a:xfrm>
            <a:off x="216056" y="0"/>
            <a:ext cx="4104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A) Melatonin treated, Low HAI Baselin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87D42A-2E11-4838-8CC1-7A1BFD9C8923}"/>
              </a:ext>
            </a:extLst>
          </p:cNvPr>
          <p:cNvSpPr txBox="1"/>
          <p:nvPr/>
        </p:nvSpPr>
        <p:spPr>
          <a:xfrm>
            <a:off x="449783" y="5029200"/>
            <a:ext cx="34364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 Control, Low HAI Baseline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331EBF-FB7C-1156-0CE1-3D91D64882F3}"/>
              </a:ext>
            </a:extLst>
          </p:cNvPr>
          <p:cNvSpPr txBox="1"/>
          <p:nvPr/>
        </p:nvSpPr>
        <p:spPr>
          <a:xfrm>
            <a:off x="4983995" y="462124"/>
            <a:ext cx="2636006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1200"/>
              </a:spcBef>
              <a:spcAft>
                <a:spcPts val="1200"/>
              </a:spcAft>
              <a:tabLst>
                <a:tab pos="3701415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Effect of pre-existing titers on post-vaccination fold-change of the HAI titers and HA antigen-specific immune mediators in the low HAI baseline group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matrices show the correlation between pre-existing titers (Pre) and post-vaccination fold-change (FC) of the selected immune mediators in the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latonin recipients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vaccinees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1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Only significant correlations (P &lt; 0.05) are displayed in each correlation matrix. Positive correlations, blue; Negative correlations, red. Color intensity and the size of the circle are proportional to the correlation coefficients (r) calculated using Spearman R. </a:t>
            </a:r>
          </a:p>
        </p:txBody>
      </p:sp>
    </p:spTree>
    <p:extLst>
      <p:ext uri="{BB962C8B-B14F-4D97-AF65-F5344CB8AC3E}">
        <p14:creationId xmlns:p14="http://schemas.microsoft.com/office/powerpoint/2010/main" val="5353062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4987F2C-9FD4-E99F-6CA9-0F76C124E9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227029"/>
              </p:ext>
            </p:extLst>
          </p:nvPr>
        </p:nvGraphicFramePr>
        <p:xfrm>
          <a:off x="838" y="4491967"/>
          <a:ext cx="2223311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222624" imgH="2604322" progId="Prism10.Document">
                  <p:embed/>
                </p:oleObj>
              </mc:Choice>
              <mc:Fallback>
                <p:oleObj name="Prism 10" r:id="rId3" imgW="4222624" imgH="260432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4987F2C-9FD4-E99F-6CA9-0F76C124E9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8" y="4491967"/>
                        <a:ext cx="2223311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99A5EC2-6BE8-854B-98ED-31618C0CAD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0001290"/>
              </p:ext>
            </p:extLst>
          </p:nvPr>
        </p:nvGraphicFramePr>
        <p:xfrm>
          <a:off x="3825859" y="1512964"/>
          <a:ext cx="2220913" cy="1370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4224064" imgH="2604322" progId="Prism10.Document">
                  <p:embed/>
                </p:oleObj>
              </mc:Choice>
              <mc:Fallback>
                <p:oleObj name="Prism 10" r:id="rId5" imgW="4224064" imgH="2604322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199A5EC2-6BE8-854B-98ED-31618C0CAD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25859" y="1512964"/>
                        <a:ext cx="2220913" cy="1370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1397185F-2A81-CCF1-56BF-B38FE13487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1115557"/>
              </p:ext>
            </p:extLst>
          </p:nvPr>
        </p:nvGraphicFramePr>
        <p:xfrm>
          <a:off x="5822096" y="1464443"/>
          <a:ext cx="2221992" cy="14083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4109598" imgH="2604322" progId="Prism10.Document">
                  <p:embed/>
                </p:oleObj>
              </mc:Choice>
              <mc:Fallback>
                <p:oleObj name="Prism 10" r:id="rId7" imgW="4109598" imgH="2604322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1397185F-2A81-CCF1-56BF-B38FE13487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822096" y="1464443"/>
                        <a:ext cx="2221992" cy="14083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A64101C-52EE-9890-5A9E-B3F36CAD80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369686"/>
              </p:ext>
            </p:extLst>
          </p:nvPr>
        </p:nvGraphicFramePr>
        <p:xfrm>
          <a:off x="0" y="66473"/>
          <a:ext cx="2217737" cy="1370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4214705" imgH="2604322" progId="Prism10.Document">
                  <p:embed/>
                </p:oleObj>
              </mc:Choice>
              <mc:Fallback>
                <p:oleObj name="Prism 10" r:id="rId9" imgW="4214705" imgH="2604322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A64101C-52EE-9890-5A9E-B3F36CAD80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66473"/>
                        <a:ext cx="2217737" cy="1370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392B56CF-114D-0BE7-EEA9-E4D5A245D0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6561757"/>
              </p:ext>
            </p:extLst>
          </p:nvPr>
        </p:nvGraphicFramePr>
        <p:xfrm>
          <a:off x="3865336" y="3117548"/>
          <a:ext cx="2221992" cy="1334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4336729" imgH="2604322" progId="Prism10.Document">
                  <p:embed/>
                </p:oleObj>
              </mc:Choice>
              <mc:Fallback>
                <p:oleObj name="Prism 10" r:id="rId11" imgW="4336729" imgH="2604322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392B56CF-114D-0BE7-EEA9-E4D5A245D0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65336" y="3117548"/>
                        <a:ext cx="2221992" cy="1334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80CCFFD4-01D2-E580-4DA3-C7EEBC16A2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1277300"/>
              </p:ext>
            </p:extLst>
          </p:nvPr>
        </p:nvGraphicFramePr>
        <p:xfrm>
          <a:off x="5819088" y="3115416"/>
          <a:ext cx="2179637" cy="1384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4102039" imgH="2604322" progId="Prism10.Document">
                  <p:embed/>
                </p:oleObj>
              </mc:Choice>
              <mc:Fallback>
                <p:oleObj name="Prism 10" r:id="rId13" imgW="4102039" imgH="2604322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80CCFFD4-01D2-E580-4DA3-C7EEBC16A2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819088" y="3115416"/>
                        <a:ext cx="2179637" cy="1384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288AFD4C-3832-B81A-1AE9-54A6BEED45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8749277"/>
              </p:ext>
            </p:extLst>
          </p:nvPr>
        </p:nvGraphicFramePr>
        <p:xfrm>
          <a:off x="4239199" y="6082013"/>
          <a:ext cx="2221992" cy="1391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4158552" imgH="2604322" progId="Prism10.Document">
                  <p:embed/>
                </p:oleObj>
              </mc:Choice>
              <mc:Fallback>
                <p:oleObj name="Prism 10" r:id="rId15" imgW="4158552" imgH="2604322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288AFD4C-3832-B81A-1AE9-54A6BEED45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239199" y="6082013"/>
                        <a:ext cx="2221992" cy="1391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BE31C45B-F554-ACD6-721F-C18BE9496A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1672287"/>
              </p:ext>
            </p:extLst>
          </p:nvPr>
        </p:nvGraphicFramePr>
        <p:xfrm>
          <a:off x="1949012" y="4471565"/>
          <a:ext cx="2222477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4220824" imgH="2604322" progId="Prism10.Document">
                  <p:embed/>
                </p:oleObj>
              </mc:Choice>
              <mc:Fallback>
                <p:oleObj name="Prism 10" r:id="rId17" imgW="4220824" imgH="2604322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BE31C45B-F554-ACD6-721F-C18BE9496A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949012" y="4471565"/>
                        <a:ext cx="2222477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A68E0039-8883-330D-9B65-EC09E7A24D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0163289"/>
              </p:ext>
            </p:extLst>
          </p:nvPr>
        </p:nvGraphicFramePr>
        <p:xfrm>
          <a:off x="1891070" y="134674"/>
          <a:ext cx="2221992" cy="13692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4226943" imgH="2604322" progId="Prism10.Document">
                  <p:embed/>
                </p:oleObj>
              </mc:Choice>
              <mc:Fallback>
                <p:oleObj name="Prism 10" r:id="rId19" imgW="4226943" imgH="260432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A68E0039-8883-330D-9B65-EC09E7A24D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891070" y="134674"/>
                        <a:ext cx="2221992" cy="13692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2A9226CD-36D9-988E-1BEA-49CEDD97AA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4582455"/>
              </p:ext>
            </p:extLst>
          </p:nvPr>
        </p:nvGraphicFramePr>
        <p:xfrm>
          <a:off x="3904528" y="42386"/>
          <a:ext cx="2221992" cy="14100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4105279" imgH="2604322" progId="Prism10.Document">
                  <p:embed/>
                </p:oleObj>
              </mc:Choice>
              <mc:Fallback>
                <p:oleObj name="Prism 10" r:id="rId21" imgW="4105279" imgH="2604322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2A9226CD-36D9-988E-1BEA-49CEDD97AA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904528" y="42386"/>
                        <a:ext cx="2221992" cy="14100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1109E3FB-F373-C2BE-E081-B0EACEC357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3138980"/>
              </p:ext>
            </p:extLst>
          </p:nvPr>
        </p:nvGraphicFramePr>
        <p:xfrm>
          <a:off x="5819088" y="0"/>
          <a:ext cx="2221992" cy="14111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4102039" imgH="2604322" progId="Prism10.Document">
                  <p:embed/>
                </p:oleObj>
              </mc:Choice>
              <mc:Fallback>
                <p:oleObj name="Prism 10" r:id="rId23" imgW="4102039" imgH="2604322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1109E3FB-F373-C2BE-E081-B0EACEC357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819088" y="0"/>
                        <a:ext cx="2221992" cy="14111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AD3BA805-6C1C-D9AD-AA59-829188539D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977319"/>
              </p:ext>
            </p:extLst>
          </p:nvPr>
        </p:nvGraphicFramePr>
        <p:xfrm>
          <a:off x="0" y="1472946"/>
          <a:ext cx="22241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4224064" imgH="2604322" progId="Prism10.Document">
                  <p:embed/>
                </p:oleObj>
              </mc:Choice>
              <mc:Fallback>
                <p:oleObj name="Prism 10" r:id="rId25" imgW="4224064" imgH="2604322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AD3BA805-6C1C-D9AD-AA59-829188539D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0" y="1472946"/>
                        <a:ext cx="22241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02020BCC-9D2E-DB78-0BDE-E4A2EAB8E7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7301100"/>
              </p:ext>
            </p:extLst>
          </p:nvPr>
        </p:nvGraphicFramePr>
        <p:xfrm>
          <a:off x="1949012" y="1478532"/>
          <a:ext cx="2221992" cy="14062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4117157" imgH="2604322" progId="Prism10.Document">
                  <p:embed/>
                </p:oleObj>
              </mc:Choice>
              <mc:Fallback>
                <p:oleObj name="Prism 10" r:id="rId27" imgW="4117157" imgH="2604322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02020BCC-9D2E-DB78-0BDE-E4A2EAB8E7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949012" y="1478532"/>
                        <a:ext cx="2221992" cy="14062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3F54AD4B-387C-0F9D-FF1F-B920A2995A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0647290"/>
              </p:ext>
            </p:extLst>
          </p:nvPr>
        </p:nvGraphicFramePr>
        <p:xfrm>
          <a:off x="-18027" y="2928846"/>
          <a:ext cx="2221992" cy="1490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4102039" imgH="2750467" progId="Prism10.Document">
                  <p:embed/>
                </p:oleObj>
              </mc:Choice>
              <mc:Fallback>
                <p:oleObj name="Prism 10" r:id="rId29" imgW="4102039" imgH="2750467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3F54AD4B-387C-0F9D-FF1F-B920A2995A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-18027" y="2928846"/>
                        <a:ext cx="2221992" cy="1490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BCB443E8-3A42-B4AE-DB27-7C15F549A0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4060830"/>
              </p:ext>
            </p:extLst>
          </p:nvPr>
        </p:nvGraphicFramePr>
        <p:xfrm>
          <a:off x="1888897" y="3123744"/>
          <a:ext cx="2221992" cy="13036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4440396" imgH="2604322" progId="Prism10.Document">
                  <p:embed/>
                </p:oleObj>
              </mc:Choice>
              <mc:Fallback>
                <p:oleObj name="Prism 10" r:id="rId31" imgW="4440396" imgH="2604322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BCB443E8-3A42-B4AE-DB27-7C15F549A0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888897" y="3123744"/>
                        <a:ext cx="2221992" cy="13036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F12F4605-042B-B95B-E069-32DE7C7354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3775748"/>
              </p:ext>
            </p:extLst>
          </p:nvPr>
        </p:nvGraphicFramePr>
        <p:xfrm>
          <a:off x="5822689" y="4559514"/>
          <a:ext cx="222080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4217944" imgH="2604322" progId="Prism10.Document">
                  <p:embed/>
                </p:oleObj>
              </mc:Choice>
              <mc:Fallback>
                <p:oleObj name="Prism 10" r:id="rId33" imgW="4217944" imgH="2604322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F12F4605-042B-B95B-E069-32DE7C7354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5822689" y="4559514"/>
                        <a:ext cx="222080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F6D94D76-61E4-5920-582C-67AB1F8A06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786536"/>
              </p:ext>
            </p:extLst>
          </p:nvPr>
        </p:nvGraphicFramePr>
        <p:xfrm>
          <a:off x="3884886" y="4509873"/>
          <a:ext cx="222080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4217944" imgH="2604322" progId="Prism10.Document">
                  <p:embed/>
                </p:oleObj>
              </mc:Choice>
              <mc:Fallback>
                <p:oleObj name="Prism 10" r:id="rId35" imgW="4217944" imgH="2604322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F6D94D76-61E4-5920-582C-67AB1F8A06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3884886" y="4509873"/>
                        <a:ext cx="222080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11BB9A92-D53E-46F8-B5B8-583F845769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3548409"/>
              </p:ext>
            </p:extLst>
          </p:nvPr>
        </p:nvGraphicFramePr>
        <p:xfrm>
          <a:off x="-18027" y="6026945"/>
          <a:ext cx="2221992" cy="14100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4105279" imgH="2604322" progId="Prism10.Document">
                  <p:embed/>
                </p:oleObj>
              </mc:Choice>
              <mc:Fallback>
                <p:oleObj name="Prism 10" r:id="rId37" imgW="4105279" imgH="2604322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11BB9A92-D53E-46F8-B5B8-583F845769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-18027" y="6026945"/>
                        <a:ext cx="2221992" cy="14100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FFE82C41-205B-4E16-0A83-87B76DAB16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7537229"/>
              </p:ext>
            </p:extLst>
          </p:nvPr>
        </p:nvGraphicFramePr>
        <p:xfrm>
          <a:off x="2108672" y="6082013"/>
          <a:ext cx="2225820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4226943" imgH="2604322" progId="Prism10.Document">
                  <p:embed/>
                </p:oleObj>
              </mc:Choice>
              <mc:Fallback>
                <p:oleObj name="Prism 10" r:id="rId39" imgW="4226943" imgH="2604322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FFE82C41-205B-4E16-0A83-87B76DAB16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2108672" y="6082013"/>
                        <a:ext cx="2225820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096BC1DF-61DE-526A-C3B7-AF05F022FEAB}"/>
              </a:ext>
            </a:extLst>
          </p:cNvPr>
          <p:cNvGrpSpPr/>
          <p:nvPr/>
        </p:nvGrpSpPr>
        <p:grpSpPr>
          <a:xfrm>
            <a:off x="3221582" y="7609280"/>
            <a:ext cx="2384527" cy="804313"/>
            <a:chOff x="5257800" y="2928895"/>
            <a:chExt cx="2738445" cy="91844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486C9E4B-BE80-9D78-368F-18A6D8008CD4}"/>
                </a:ext>
              </a:extLst>
            </p:cNvPr>
            <p:cNvGrpSpPr/>
            <p:nvPr/>
          </p:nvGrpSpPr>
          <p:grpSpPr>
            <a:xfrm>
              <a:off x="5257800" y="3249876"/>
              <a:ext cx="2738445" cy="597466"/>
              <a:chOff x="2646967" y="1341129"/>
              <a:chExt cx="4532540" cy="1328019"/>
            </a:xfrm>
          </p:grpSpPr>
          <p:sp>
            <p:nvSpPr>
              <p:cNvPr id="6" name="Oval 5">
                <a:extLst>
                  <a:ext uri="{FF2B5EF4-FFF2-40B4-BE49-F238E27FC236}">
                    <a16:creationId xmlns:a16="http://schemas.microsoft.com/office/drawing/2014/main" id="{658F8BEB-BACB-F7A9-F2C0-0857C06736FB}"/>
                  </a:ext>
                </a:extLst>
              </p:cNvPr>
              <p:cNvSpPr/>
              <p:nvPr/>
            </p:nvSpPr>
            <p:spPr>
              <a:xfrm>
                <a:off x="2646967" y="1565973"/>
                <a:ext cx="260716" cy="348135"/>
              </a:xfrm>
              <a:prstGeom prst="ellipse">
                <a:avLst/>
              </a:prstGeom>
              <a:solidFill>
                <a:srgbClr val="FA2476"/>
              </a:solidFill>
              <a:ln w="254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2D25E0C-1C74-9DC5-1B6A-DF9DA88063BF}"/>
                  </a:ext>
                </a:extLst>
              </p:cNvPr>
              <p:cNvSpPr txBox="1"/>
              <p:nvPr/>
            </p:nvSpPr>
            <p:spPr>
              <a:xfrm>
                <a:off x="4917262" y="1372112"/>
                <a:ext cx="2262245" cy="6841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8" name="Oval 7">
                <a:extLst>
                  <a:ext uri="{FF2B5EF4-FFF2-40B4-BE49-F238E27FC236}">
                    <a16:creationId xmlns:a16="http://schemas.microsoft.com/office/drawing/2014/main" id="{3BA11BCB-181C-97A0-69BB-0A089499DADE}"/>
                  </a:ext>
                </a:extLst>
              </p:cNvPr>
              <p:cNvSpPr/>
              <p:nvPr/>
            </p:nvSpPr>
            <p:spPr>
              <a:xfrm>
                <a:off x="4786904" y="1583587"/>
                <a:ext cx="260716" cy="348135"/>
              </a:xfrm>
              <a:prstGeom prst="ellipse">
                <a:avLst/>
              </a:prstGeom>
              <a:solidFill>
                <a:schemeClr val="accent5">
                  <a:lumMod val="75000"/>
                </a:schemeClr>
              </a:solidFill>
              <a:ln w="254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F76FFB2-1901-2D35-193E-6EB2C7575658}"/>
                  </a:ext>
                </a:extLst>
              </p:cNvPr>
              <p:cNvSpPr txBox="1"/>
              <p:nvPr/>
            </p:nvSpPr>
            <p:spPr>
              <a:xfrm>
                <a:off x="2752772" y="1341129"/>
                <a:ext cx="2018947" cy="1328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latonin treated 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4D94813-B21C-7157-BC17-307624816A60}"/>
                </a:ext>
              </a:extLst>
            </p:cNvPr>
            <p:cNvSpPr txBox="1"/>
            <p:nvPr/>
          </p:nvSpPr>
          <p:spPr>
            <a:xfrm flipH="1">
              <a:off x="5477961" y="2928895"/>
              <a:ext cx="2233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ow HAI Baseline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F152FC78-96DA-8706-889C-4A19D9BF7E02}"/>
              </a:ext>
            </a:extLst>
          </p:cNvPr>
          <p:cNvGrpSpPr/>
          <p:nvPr/>
        </p:nvGrpSpPr>
        <p:grpSpPr>
          <a:xfrm>
            <a:off x="175210" y="7536319"/>
            <a:ext cx="2583822" cy="835936"/>
            <a:chOff x="5179269" y="2112395"/>
            <a:chExt cx="2746510" cy="506451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DE17AB4A-A738-74E8-AF9C-D1072FF00E80}"/>
                </a:ext>
              </a:extLst>
            </p:cNvPr>
            <p:cNvGrpSpPr/>
            <p:nvPr/>
          </p:nvGrpSpPr>
          <p:grpSpPr>
            <a:xfrm>
              <a:off x="5179269" y="2288904"/>
              <a:ext cx="2746510" cy="329942"/>
              <a:chOff x="2644229" y="1428457"/>
              <a:chExt cx="4545889" cy="733378"/>
            </a:xfrm>
          </p:grpSpPr>
          <p:sp>
            <p:nvSpPr>
              <p:cNvPr id="17" name="Oval 16">
                <a:extLst>
                  <a:ext uri="{FF2B5EF4-FFF2-40B4-BE49-F238E27FC236}">
                    <a16:creationId xmlns:a16="http://schemas.microsoft.com/office/drawing/2014/main" id="{28224792-D757-3967-CF24-EBB2E90A7D82}"/>
                  </a:ext>
                </a:extLst>
              </p:cNvPr>
              <p:cNvSpPr/>
              <p:nvPr/>
            </p:nvSpPr>
            <p:spPr>
              <a:xfrm>
                <a:off x="2646967" y="1565972"/>
                <a:ext cx="241315" cy="184707"/>
              </a:xfrm>
              <a:prstGeom prst="ellipse">
                <a:avLst/>
              </a:prstGeom>
              <a:solidFill>
                <a:schemeClr val="accent2"/>
              </a:solidFill>
              <a:ln w="254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430D3471-B56F-1CB3-2B14-C5A20AB7E766}"/>
                  </a:ext>
                </a:extLst>
              </p:cNvPr>
              <p:cNvSpPr txBox="1"/>
              <p:nvPr/>
            </p:nvSpPr>
            <p:spPr>
              <a:xfrm>
                <a:off x="4927872" y="1477723"/>
                <a:ext cx="2262246" cy="684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47" name="Oval 46">
                <a:extLst>
                  <a:ext uri="{FF2B5EF4-FFF2-40B4-BE49-F238E27FC236}">
                    <a16:creationId xmlns:a16="http://schemas.microsoft.com/office/drawing/2014/main" id="{23829299-EAAA-C605-0D5B-5E9CFFD11E10}"/>
                  </a:ext>
                </a:extLst>
              </p:cNvPr>
              <p:cNvSpPr/>
              <p:nvPr/>
            </p:nvSpPr>
            <p:spPr>
              <a:xfrm>
                <a:off x="4786906" y="1583586"/>
                <a:ext cx="241315" cy="184707"/>
              </a:xfrm>
              <a:prstGeom prst="ellipse">
                <a:avLst/>
              </a:prstGeom>
              <a:solidFill>
                <a:srgbClr val="00B050"/>
              </a:solidFill>
              <a:ln w="254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BDC28106-4245-02FE-905B-CC4E4489C45A}"/>
                  </a:ext>
                </a:extLst>
              </p:cNvPr>
              <p:cNvSpPr txBox="1"/>
              <p:nvPr/>
            </p:nvSpPr>
            <p:spPr>
              <a:xfrm>
                <a:off x="2644229" y="1428457"/>
                <a:ext cx="2209099" cy="7045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latonin treated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1323B54-6781-50A8-AD61-AB15B81486A7}"/>
                </a:ext>
              </a:extLst>
            </p:cNvPr>
            <p:cNvSpPr txBox="1"/>
            <p:nvPr/>
          </p:nvSpPr>
          <p:spPr>
            <a:xfrm flipH="1">
              <a:off x="5371757" y="2112395"/>
              <a:ext cx="2233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igh HAI Baseline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DBA35F6D-D5C6-EBB0-D5BD-18D57CAB061A}"/>
              </a:ext>
            </a:extLst>
          </p:cNvPr>
          <p:cNvSpPr txBox="1"/>
          <p:nvPr/>
        </p:nvSpPr>
        <p:spPr>
          <a:xfrm>
            <a:off x="175210" y="8663135"/>
            <a:ext cx="733049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  <a:tabLst>
                <a:tab pos="3701415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tigen-specific cytokine responses in the melatonin and control vaccine recipients stratified by the baseline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scatter plots represent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the cytokines those were present above the detectable levels by the mesoscale assay. The mean value for each cohort is represented by a short, dashed line on the scatter plots. Melatonin high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Control high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3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Melatonin low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Control low HAI baseline,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11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5793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8903a443-af33-4ed4-acf5-ee613bcb2f59}" enabled="0" method="" siteId="{8903a443-af33-4ed4-acf5-ee613bcb2f59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170</TotalTime>
  <Words>932</Words>
  <Application>Microsoft Office PowerPoint</Application>
  <PresentationFormat>Custom</PresentationFormat>
  <Paragraphs>61</Paragraphs>
  <Slides>5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Wingdings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jayalath Arachchige, Wathsala K CTR USN NMRC (USA)</dc:creator>
  <cp:lastModifiedBy>Wijayalath Arachchige, Wathsala K CTR USN NMRC (USA)</cp:lastModifiedBy>
  <cp:revision>9</cp:revision>
  <dcterms:created xsi:type="dcterms:W3CDTF">2024-06-01T22:07:48Z</dcterms:created>
  <dcterms:modified xsi:type="dcterms:W3CDTF">2025-10-15T21:33:41Z</dcterms:modified>
</cp:coreProperties>
</file>